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432000" y="1489341"/>
            <a:ext cx="8280000" cy="4156317"/>
            <a:chOff x="424543" y="43613"/>
            <a:chExt cx="8280000" cy="4156317"/>
          </a:xfrm>
        </p:grpSpPr>
        <p:grpSp>
          <p:nvGrpSpPr>
            <p:cNvPr id="7" name="Group 6"/>
            <p:cNvGrpSpPr/>
            <p:nvPr/>
          </p:nvGrpSpPr>
          <p:grpSpPr>
            <a:xfrm>
              <a:off x="424543" y="43613"/>
              <a:ext cx="8280000" cy="3004387"/>
              <a:chOff x="424543" y="43613"/>
              <a:chExt cx="8280000" cy="3004387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4543" y="1450677"/>
                <a:ext cx="8280000" cy="15973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 rot="18511719">
                <a:off x="4831565" y="838127"/>
                <a:ext cx="1142392" cy="3650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Control</a:t>
                </a:r>
                <a:endParaRPr lang="en-IN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 rot="18300068">
                <a:off x="5596935" y="762694"/>
                <a:ext cx="1284224" cy="3650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CUR only</a:t>
                </a:r>
                <a:endParaRPr lang="en-IN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8319404">
                <a:off x="6361961" y="678384"/>
                <a:ext cx="1612135" cy="3650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CUR NP (7:3)</a:t>
                </a:r>
                <a:endParaRPr lang="en-IN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 rot="18236878">
                <a:off x="7085211" y="667146"/>
                <a:ext cx="1612135" cy="3650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CUR NP (6:4)</a:t>
                </a:r>
                <a:endParaRPr lang="en-IN" dirty="0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433414" y="3276600"/>
              <a:ext cx="8262257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WB-1 for GAPDH– The last four bands corresponds to the four samples shown in the present manuscript. The first five bands are for other study and is our unpublished data.</a:t>
              </a:r>
              <a:endParaRPr lang="en-IN" dirty="0"/>
            </a:p>
          </p:txBody>
        </p:sp>
      </p:grpSp>
    </p:spTree>
    <p:extLst>
      <p:ext uri="{BB962C8B-B14F-4D97-AF65-F5344CB8AC3E}">
        <p14:creationId xmlns:p14="http://schemas.microsoft.com/office/powerpoint/2010/main" val="97073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432000" y="830859"/>
            <a:ext cx="8280000" cy="5196283"/>
            <a:chOff x="432000" y="442517"/>
            <a:chExt cx="8280000" cy="5196283"/>
          </a:xfrm>
        </p:grpSpPr>
        <p:pic>
          <p:nvPicPr>
            <p:cNvPr id="2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2000" y="2013486"/>
              <a:ext cx="8280000" cy="28310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 rot="18511719">
              <a:off x="3508802" y="1292451"/>
              <a:ext cx="1142392" cy="365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Control</a:t>
              </a:r>
              <a:endParaRPr lang="en-IN" dirty="0"/>
            </a:p>
          </p:txBody>
        </p:sp>
        <p:sp>
          <p:nvSpPr>
            <p:cNvPr id="4" name="TextBox 3"/>
            <p:cNvSpPr txBox="1"/>
            <p:nvPr/>
          </p:nvSpPr>
          <p:spPr>
            <a:xfrm rot="18300068">
              <a:off x="4904205" y="1217018"/>
              <a:ext cx="1284224" cy="365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CUR only</a:t>
              </a:r>
              <a:endParaRPr lang="en-IN" dirty="0"/>
            </a:p>
          </p:txBody>
        </p:sp>
        <p:sp>
          <p:nvSpPr>
            <p:cNvPr id="5" name="TextBox 4"/>
            <p:cNvSpPr txBox="1"/>
            <p:nvPr/>
          </p:nvSpPr>
          <p:spPr>
            <a:xfrm rot="18319404">
              <a:off x="6320416" y="1077288"/>
              <a:ext cx="1612135" cy="365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CUR NP (7:3)</a:t>
              </a:r>
              <a:endParaRPr lang="en-IN" dirty="0"/>
            </a:p>
          </p:txBody>
        </p:sp>
        <p:sp>
          <p:nvSpPr>
            <p:cNvPr id="6" name="TextBox 5"/>
            <p:cNvSpPr txBox="1"/>
            <p:nvPr/>
          </p:nvSpPr>
          <p:spPr>
            <a:xfrm rot="18236878">
              <a:off x="7542446" y="1066050"/>
              <a:ext cx="1612135" cy="365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CUR NP (6:4)</a:t>
              </a:r>
              <a:endParaRPr lang="en-IN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40871" y="4992469"/>
              <a:ext cx="82622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WB-2 for Procaspase 9– The first two bands are for marker and the last four bands corresponds to the four samples shown in the present manuscript. </a:t>
              </a:r>
              <a:endParaRPr lang="en-IN" dirty="0"/>
            </a:p>
          </p:txBody>
        </p:sp>
      </p:grpSp>
    </p:spTree>
    <p:extLst>
      <p:ext uri="{BB962C8B-B14F-4D97-AF65-F5344CB8AC3E}">
        <p14:creationId xmlns:p14="http://schemas.microsoft.com/office/powerpoint/2010/main" val="998438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7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SURENDRA</cp:lastModifiedBy>
  <cp:revision>2</cp:revision>
  <dcterms:created xsi:type="dcterms:W3CDTF">2006-08-16T00:00:00Z</dcterms:created>
  <dcterms:modified xsi:type="dcterms:W3CDTF">2020-11-10T09:17:40Z</dcterms:modified>
</cp:coreProperties>
</file>